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0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40243B-C9D9-4E37-8A9B-975BA0714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A714692-240B-41C5-8C90-F164BAD8D7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9EF380-C5C3-4129-8EEE-D4E623AC8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BB1000-A6C0-4C62-B2EA-1FD1D9783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E3F364-DC77-44FD-8491-23302B6B0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61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F54C79-CE91-4E61-8E4D-D33854ED0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DFD16E-473E-4D8B-A930-A65036E80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A1B09-20F6-48E8-B7A4-59C60E4C6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D38E91-8B3C-42C4-81BA-2A528F65A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8CFB91-036B-455E-ADB7-9BCA99A45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755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AF64375-249E-4A22-B075-930765B156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0D4BDBB-E397-401F-81CC-ACD122A42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2B769-92F2-4A7C-A9AE-92647EE79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978F82-22F3-4700-905C-B8BF30FA6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A028F0-7A7E-4402-8B38-E013B57CE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94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32A81-633D-4770-80E3-A7A9DDD1B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7CBB39-00E4-41AC-A959-E946ABF61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656EC8-08E9-44FD-BCFA-0F41EB319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44FEB1-A99B-445C-9FDD-26525761A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1EB348-1246-4E52-9BF8-63186A603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57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2F3AAD-9A47-4021-9DD9-6228DA476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04A4F6-104B-419C-BB48-F4C993E0F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BA6A41-D01F-42A5-A0CB-C3858E782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B6E1E1-1D4E-46ED-ABE7-9809687FE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CF9A44-A457-4832-BF3D-DD4F4B160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45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DFBED2-9502-4A6E-9B63-6FD5D4C81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38064D-07F7-4F1C-B27F-2EBBE2CB19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ADBD82-67F9-480E-9432-3763B19B37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2A9A7C-C81A-4CA4-975E-A60478CCD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52C19B-593E-4BA2-BB98-C13F5328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69C6D4-056C-4CB7-A498-2298945DB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51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32F730-5371-47F1-B409-A5EA0A7D76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7530FC-E9BF-4073-8401-C6C23EF02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936AD0-1C01-439A-B5AA-D0CF7C96C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27F032-1417-4983-B5B7-DBC3D6FFD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1EC7F1C-5D7C-4352-B083-8B2D581E6D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578B67B-AF5E-4672-9A72-D4789F00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85725B8-1C48-419D-B7F3-8927ABCAA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82102D0-C63F-4A18-A7D1-BA31B9A89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6365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659908-829A-456D-96A3-24686DDA2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A86B67D-AF34-4215-A1F8-513DA4717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00DA581-5376-4789-9A85-EE2D12191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AB3051E-C5C3-47E4-A22A-EB298DC97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9717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2BEF6F9-93DC-4307-9D39-F0E43AF5A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D19725D-91E4-4FEE-8026-BE495B9B6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6FA0E68-5D0B-4062-AD51-69B71FEFA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552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426F6B-2031-490C-A5A1-65A46833B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5BFA83-4F0E-48B7-A0D0-99003B0259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35C5ED-0C58-4A9C-AFAC-BDAC71E895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E7E3A4-5DDB-4572-BEE1-ADA34AA13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C9AD49-1057-4906-AD26-A3BF50F48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353386-48BC-441A-AF4F-EA28190F8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293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4EF8F9-F59E-4069-8FE5-2FE2FE57F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A3F154-31B2-4BEE-94E9-6B8D74BAAF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1A9FAF-7263-4725-A1FD-9E39D8EFA0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23A9AF-2003-4B75-81D2-AA19AE85A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697D45-5293-4E16-AD0B-CFCBA799F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DA7F62-83E4-4285-8BB4-718119A4D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479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46B0D66-E7A9-404C-802C-1EBC6B2DE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3C41F8-CAC3-4F72-B536-F69A4C9D7F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2B3CA-E3A6-4CCE-9F05-A2E288C4AB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5B4F2E-532A-4F73-B9F5-358176767D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FCDDD7-43F4-42EC-A33C-A6605D4619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141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6B</a:t>
            </a:r>
            <a:endParaRPr lang="zh-CN" altLang="en-US" dirty="0"/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BAD7038F-4691-4489-9992-7AE4B4C195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3730260"/>
              </p:ext>
            </p:extLst>
          </p:nvPr>
        </p:nvGraphicFramePr>
        <p:xfrm>
          <a:off x="3940175" y="839788"/>
          <a:ext cx="3949700" cy="2814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950329" imgH="2815209" progId="Prism8.Document">
                  <p:embed/>
                </p:oleObj>
              </mc:Choice>
              <mc:Fallback>
                <p:oleObj name="Prism 8" r:id="rId2" imgW="3950329" imgH="281520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40175" y="839788"/>
                        <a:ext cx="3949700" cy="2814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B2959823-9883-4B89-AC7F-6D1E87A45C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4370486"/>
              </p:ext>
            </p:extLst>
          </p:nvPr>
        </p:nvGraphicFramePr>
        <p:xfrm>
          <a:off x="838202" y="3871044"/>
          <a:ext cx="10515595" cy="2727639"/>
        </p:xfrm>
        <a:graphic>
          <a:graphicData uri="http://schemas.openxmlformats.org/drawingml/2006/table">
            <a:tbl>
              <a:tblPr/>
              <a:tblGrid>
                <a:gridCol w="364402">
                  <a:extLst>
                    <a:ext uri="{9D8B030D-6E8A-4147-A177-3AD203B41FA5}">
                      <a16:colId xmlns:a16="http://schemas.microsoft.com/office/drawing/2014/main" val="3652358828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596273086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2022597023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1741766963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1427284136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280717118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489666592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1408231985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4290226555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3739191209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3723993216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3635180585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705351290"/>
                    </a:ext>
                  </a:extLst>
                </a:gridCol>
                <a:gridCol w="780861">
                  <a:extLst>
                    <a:ext uri="{9D8B030D-6E8A-4147-A177-3AD203B41FA5}">
                      <a16:colId xmlns:a16="http://schemas.microsoft.com/office/drawing/2014/main" val="3038353555"/>
                    </a:ext>
                  </a:extLst>
                </a:gridCol>
              </a:tblGrid>
              <a:tr h="303071">
                <a:tc>
                  <a:txBody>
                    <a:bodyPr/>
                    <a:lstStyle/>
                    <a:p>
                      <a:pPr algn="ct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Day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control shRNA+Cis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Arial" panose="020B0604020202020204" pitchFamily="34" charset="0"/>
                        </a:rPr>
                        <a:t>sestrin2 shRNA+Cis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6875304"/>
                  </a:ext>
                </a:extLst>
              </a:tr>
              <a:tr h="30307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6.6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5.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1.4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3.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2.2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8.4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0.4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1.1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9.1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2.0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1.3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3.5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9433825"/>
                  </a:ext>
                </a:extLst>
              </a:tr>
              <a:tr h="30307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0.3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5.3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9.29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3.5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7.4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8.36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8.5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1.6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0.5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3.8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4.8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4.7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1480715"/>
                  </a:ext>
                </a:extLst>
              </a:tr>
              <a:tr h="30307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9.3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2.9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7.2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5.7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2.7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2.1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4.4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2.66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1.4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7.0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6.3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5.4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0551055"/>
                  </a:ext>
                </a:extLst>
              </a:tr>
              <a:tr h="30307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36.8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92.4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56.16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57.0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82.19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23.1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50.36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9.09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77.5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5.2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7.8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5.8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4039040"/>
                  </a:ext>
                </a:extLst>
              </a:tr>
              <a:tr h="30307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13.3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07.7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51.3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58.4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91.7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01.6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192.4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78.4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11.39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9.4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3.5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79.39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8643101"/>
                  </a:ext>
                </a:extLst>
              </a:tr>
              <a:tr h="30307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80.9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58.4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33.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92.26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31.4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69.7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84.6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69.76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03.7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90.7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67.5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95.7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5861911"/>
                  </a:ext>
                </a:extLst>
              </a:tr>
              <a:tr h="30307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843.4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814.5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721.3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73.5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02.1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34.8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18.31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11.8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323.49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03.7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82.8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26.9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8550127"/>
                  </a:ext>
                </a:extLst>
              </a:tr>
              <a:tr h="30307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zh-CN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967.2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962.8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834.9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63.5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83.7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623.96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516.6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55.6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487.53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12.45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>
                          <a:effectLst/>
                          <a:latin typeface="Arial" panose="020B0604020202020204" pitchFamily="34" charset="0"/>
                        </a:rPr>
                        <a:t>143.47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700" b="0" i="0" u="none" strike="noStrike" dirty="0">
                          <a:effectLst/>
                          <a:latin typeface="Arial" panose="020B0604020202020204" pitchFamily="34" charset="0"/>
                        </a:rPr>
                        <a:t>212.34</a:t>
                      </a:r>
                    </a:p>
                  </a:txBody>
                  <a:tcPr marL="4338" marR="4338" marT="43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2278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835740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76EE6B4-FAF4-45AD-8965-1C8C1CC7A911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6C</a:t>
            </a:r>
            <a:endParaRPr lang="zh-CN" altLang="en-US" dirty="0"/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230AAD65-84DC-4500-BCFA-470967DD6E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4824937"/>
              </p:ext>
            </p:extLst>
          </p:nvPr>
        </p:nvGraphicFramePr>
        <p:xfrm>
          <a:off x="4241800" y="241339"/>
          <a:ext cx="3175000" cy="3381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175677" imgH="3380843" progId="Prism8.Document">
                  <p:embed/>
                </p:oleObj>
              </mc:Choice>
              <mc:Fallback>
                <p:oleObj name="Prism 8" r:id="rId2" imgW="3175677" imgH="338084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41800" y="241339"/>
                        <a:ext cx="3175000" cy="3381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51030B2D-940C-4A9F-A570-BABB3020D6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735748"/>
              </p:ext>
            </p:extLst>
          </p:nvPr>
        </p:nvGraphicFramePr>
        <p:xfrm>
          <a:off x="2219325" y="4093369"/>
          <a:ext cx="6781800" cy="1497808"/>
        </p:xfrm>
        <a:graphic>
          <a:graphicData uri="http://schemas.openxmlformats.org/drawingml/2006/table">
            <a:tbl>
              <a:tblPr/>
              <a:tblGrid>
                <a:gridCol w="1536700">
                  <a:extLst>
                    <a:ext uri="{9D8B030D-6E8A-4147-A177-3AD203B41FA5}">
                      <a16:colId xmlns:a16="http://schemas.microsoft.com/office/drawing/2014/main" val="2058608392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501595988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val="3355518221"/>
                    </a:ext>
                  </a:extLst>
                </a:gridCol>
                <a:gridCol w="1892300">
                  <a:extLst>
                    <a:ext uri="{9D8B030D-6E8A-4147-A177-3AD203B41FA5}">
                      <a16:colId xmlns:a16="http://schemas.microsoft.com/office/drawing/2014/main" val="2638514489"/>
                    </a:ext>
                  </a:extLst>
                </a:gridCol>
              </a:tblGrid>
              <a:tr h="37445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ntrol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ntrol shRNA+Ci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estrin2 shRNA+Cis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6105439"/>
                  </a:ext>
                </a:extLst>
              </a:tr>
              <a:tr h="374452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1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0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0500829"/>
                  </a:ext>
                </a:extLst>
              </a:tr>
              <a:tr h="374452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2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3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2736909"/>
                  </a:ext>
                </a:extLst>
              </a:tr>
              <a:tr h="374452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2032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47162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147</Words>
  <Application>Microsoft Office PowerPoint</Application>
  <PresentationFormat>宽屏</PresentationFormat>
  <Paragraphs>127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GraphPad Prism 8 Project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10</cp:revision>
  <dcterms:created xsi:type="dcterms:W3CDTF">2021-06-15T01:43:45Z</dcterms:created>
  <dcterms:modified xsi:type="dcterms:W3CDTF">2021-06-15T03:36:53Z</dcterms:modified>
</cp:coreProperties>
</file>